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5"/>
  </p:handout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6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DE7B07-CA50-4227-A3C0-08D87CBE66F0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48E32A-9392-4106-8A42-5E888D0DCD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55591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760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3045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1707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7457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0912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4545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351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1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0178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6914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996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0FFAE-14C4-4030-8B37-2569DDB5CDC4}" type="datetimeFigureOut">
              <a:rPr lang="ko-KR" altLang="en-US" smtClean="0"/>
              <a:t>2018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1EDD3-9246-42BB-8F9F-272A53E76E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9594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Supplementary Figure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00213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3206" y="2128243"/>
            <a:ext cx="2314648" cy="396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5383001" y="1859839"/>
            <a:ext cx="1922106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umber of sorted stromal cells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 rot="16200000">
            <a:off x="535080" y="3899271"/>
            <a:ext cx="1922106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 ID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3187" y="2109581"/>
            <a:ext cx="2309071" cy="3960000"/>
          </a:xfrm>
          <a:prstGeom prst="rect">
            <a:avLst/>
          </a:prstGeom>
        </p:spPr>
      </p:pic>
      <p:sp>
        <p:nvSpPr>
          <p:cNvPr id="8" name="직사각형 7"/>
          <p:cNvSpPr/>
          <p:nvPr/>
        </p:nvSpPr>
        <p:spPr>
          <a:xfrm>
            <a:off x="1846670" y="1857653"/>
            <a:ext cx="1922106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umber of sorted </a:t>
            </a:r>
          </a:p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65094" y="1820397"/>
            <a:ext cx="337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 rot="16200000">
            <a:off x="4141996" y="3899271"/>
            <a:ext cx="1922106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 ID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73235" y="1810411"/>
            <a:ext cx="337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056110" y="1824513"/>
            <a:ext cx="337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8857" y="2128174"/>
            <a:ext cx="2530059" cy="1085182"/>
          </a:xfrm>
          <a:prstGeom prst="rect">
            <a:avLst/>
          </a:prstGeom>
        </p:spPr>
      </p:pic>
      <p:sp>
        <p:nvSpPr>
          <p:cNvPr id="15" name="직사각형 14"/>
          <p:cNvSpPr/>
          <p:nvPr/>
        </p:nvSpPr>
        <p:spPr>
          <a:xfrm>
            <a:off x="8468066" y="1847481"/>
            <a:ext cx="2330849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umber of sorted other minority putative tumor cells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/>
          <p:cNvSpPr/>
          <p:nvPr/>
        </p:nvSpPr>
        <p:spPr>
          <a:xfrm rot="16200000">
            <a:off x="7191171" y="3899270"/>
            <a:ext cx="1922106" cy="2332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 ID</a:t>
            </a:r>
            <a:endParaRPr lang="ko-KR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248052" y="247390"/>
            <a:ext cx="1164738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The numbers of pure cells, which are sorted by DEParray technology, are displayed. (a) Sorted tumor cells, (b) Sorted stromal cells, (c) Sorted other minority putative tumor cells</a:t>
            </a:r>
          </a:p>
        </p:txBody>
      </p:sp>
    </p:spTree>
    <p:extLst>
      <p:ext uri="{BB962C8B-B14F-4D97-AF65-F5344CB8AC3E}">
        <p14:creationId xmlns:p14="http://schemas.microsoft.com/office/powerpoint/2010/main" val="360221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152" y="1654356"/>
            <a:ext cx="6604131" cy="4850195"/>
          </a:xfrm>
          <a:prstGeom prst="rect">
            <a:avLst/>
          </a:prstGeom>
        </p:spPr>
      </p:pic>
      <p:sp>
        <p:nvSpPr>
          <p:cNvPr id="5" name="타원 4"/>
          <p:cNvSpPr/>
          <p:nvPr/>
        </p:nvSpPr>
        <p:spPr>
          <a:xfrm>
            <a:off x="7753741" y="2659574"/>
            <a:ext cx="3600000" cy="3600000"/>
          </a:xfrm>
          <a:prstGeom prst="ellipse">
            <a:avLst/>
          </a:prstGeom>
          <a:noFill/>
          <a:ln w="381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직사각형 5"/>
          <p:cNvSpPr/>
          <p:nvPr/>
        </p:nvSpPr>
        <p:spPr>
          <a:xfrm>
            <a:off x="1912777" y="1586208"/>
            <a:ext cx="2024743" cy="491834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8867941" y="2087627"/>
            <a:ext cx="1371600" cy="867747"/>
          </a:xfrm>
          <a:prstGeom prst="rect">
            <a:avLst/>
          </a:prstGeom>
          <a:solidFill>
            <a:schemeClr val="bg1"/>
          </a:solidFill>
          <a:ln w="381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atic mutations</a:t>
            </a:r>
            <a:endParaRPr lang="en-US" altLang="ko-KR" sz="14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34)</a:t>
            </a:r>
            <a:endParaRPr lang="ko-KR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타원 7"/>
          <p:cNvSpPr/>
          <p:nvPr/>
        </p:nvSpPr>
        <p:spPr>
          <a:xfrm>
            <a:off x="8204721" y="3774708"/>
            <a:ext cx="2160000" cy="2160000"/>
          </a:xfrm>
          <a:prstGeom prst="ellipse">
            <a:avLst/>
          </a:prstGeom>
          <a:noFill/>
          <a:ln w="3810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타원 8"/>
          <p:cNvSpPr/>
          <p:nvPr/>
        </p:nvSpPr>
        <p:spPr>
          <a:xfrm>
            <a:off x="8699231" y="3774708"/>
            <a:ext cx="2160000" cy="2160000"/>
          </a:xfrm>
          <a:prstGeom prst="ellipse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/>
          <p:cNvSpPr/>
          <p:nvPr/>
        </p:nvSpPr>
        <p:spPr>
          <a:xfrm>
            <a:off x="10169953" y="3508659"/>
            <a:ext cx="793517" cy="559559"/>
          </a:xfrm>
          <a:prstGeom prst="rect">
            <a:avLst/>
          </a:prstGeom>
          <a:solidFill>
            <a:schemeClr val="bg1"/>
          </a:solidFill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vel</a:t>
            </a:r>
          </a:p>
          <a:p>
            <a:pPr algn="ctr"/>
            <a:r>
              <a:rPr lang="en-US" altLang="ko-KR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ations</a:t>
            </a:r>
          </a:p>
          <a:p>
            <a:pPr algn="ctr"/>
            <a:r>
              <a:rPr lang="en-US" altLang="ko-KR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16)</a:t>
            </a:r>
            <a:endParaRPr lang="ko-KR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358501" y="4702886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313472" y="467004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278529" y="467004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8064345" y="3527321"/>
            <a:ext cx="840919" cy="622369"/>
          </a:xfrm>
          <a:prstGeom prst="rect">
            <a:avLst/>
          </a:prstGeom>
          <a:solidFill>
            <a:schemeClr val="bg1"/>
          </a:solidFill>
          <a:ln w="3810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ations in only pure tumors</a:t>
            </a:r>
          </a:p>
          <a:p>
            <a:pPr algn="ctr"/>
            <a:r>
              <a:rPr lang="en-US" altLang="ko-KR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14)</a:t>
            </a:r>
            <a:endParaRPr lang="ko-KR" alt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262174" y="279302"/>
            <a:ext cx="1164738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Novel mutation analysis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(a) Novel mutations were colored by red color, and mutations detected in only sorted cells were colored by blu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olor in 34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omatic mutations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mutations distributions we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hown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Venn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iagrams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3197" y="1657373"/>
            <a:ext cx="337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584763" y="1657372"/>
            <a:ext cx="337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356924" y="3233764"/>
            <a:ext cx="51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742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4</TotalTime>
  <Words>145</Words>
  <Application>Microsoft Office PowerPoint</Application>
  <PresentationFormat>와이드스크린</PresentationFormat>
  <Paragraphs>2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Supplementary Figures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ungbok</dc:creator>
  <cp:lastModifiedBy>Seungbok</cp:lastModifiedBy>
  <cp:revision>10</cp:revision>
  <cp:lastPrinted>2018-02-19T04:39:22Z</cp:lastPrinted>
  <dcterms:created xsi:type="dcterms:W3CDTF">2018-02-14T05:30:50Z</dcterms:created>
  <dcterms:modified xsi:type="dcterms:W3CDTF">2018-02-19T05:50:20Z</dcterms:modified>
</cp:coreProperties>
</file>